
<file path=[Content_Types].xml><?xml version="1.0" encoding="utf-8"?>
<Types xmlns="http://schemas.openxmlformats.org/package/2006/content-types">
  <Default Extension="png" ContentType="image/png"/>
  <Default Extension="mov" ContentType="video/quicktime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9"/>
    <p:restoredTop sz="94623"/>
  </p:normalViewPr>
  <p:slideViewPr>
    <p:cSldViewPr snapToGrid="0" snapToObjects="1" showGuides="1">
      <p:cViewPr varScale="1">
        <p:scale>
          <a:sx n="80" d="100"/>
          <a:sy n="80" d="100"/>
        </p:scale>
        <p:origin x="1432" y="192"/>
      </p:cViewPr>
      <p:guideLst>
        <p:guide orient="horz" pos="2136"/>
        <p:guide pos="3840"/>
      </p:guideLst>
    </p:cSldViewPr>
  </p:slideViewPr>
  <p:notesTextViewPr>
    <p:cViewPr>
      <p:scale>
        <a:sx n="85" d="100"/>
        <a:sy n="8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DD081D-F250-1F4B-A62D-33CD0D60952D}" type="datetimeFigureOut">
              <a:rPr lang="en-US" smtClean="0"/>
              <a:t>5/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019094-9D25-C540-A2BC-4214B44C9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9317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ovie S1_1080.mov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019094-9D25-C540-A2BC-4214B44C983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7657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1975BB-F124-4E4D-8015-22866D7202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4EA5F0-8C00-204C-AB82-E53CFF3024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E9FE5C-B8ED-324F-9E27-3AEB6957B1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8F2447-0AEB-4F49-8D5A-E32F2955B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83F92A-C0EA-2B4A-A784-B665CD590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959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523FF8-AA82-0448-B531-4CA833052C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2FAAF1-0376-9F42-A8ED-4202E3A991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2667AB-5453-2642-9BA3-39F21EDE1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1E7C30-F306-B042-AAFA-8ADBD6BD2E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6EA137-A799-724C-B2AF-A7907B0F96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52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8F3B6EC-88B3-0440-8967-1813ECC597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DA3690-DA06-324C-A579-FE03975A1F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1B0B1E-9EC1-AA46-97CF-9A1B046601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EC3A09-082D-7844-AB1C-350D9E59D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B120D6-4B4E-5443-9180-30D951D32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254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8DB4CC-5FD9-3F42-AC3F-3CBEB99340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3B6719-82F2-6446-B031-DBA44510C8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951EE7-41BF-C240-99E0-02150688B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46341C-25F7-514A-BBFE-9A2D22A91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1AAAB0-35A8-A448-A45F-D0F59232A4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416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201276-01DD-A54E-8E1A-72FEC8425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576CF1-5317-DF40-92E3-A5B80FBAD2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042D7E-233C-9E4E-A0FA-AAD1CBF5E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1308B9-525E-7148-912B-9EFF44AD90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6C0D9-9230-CF49-A93D-CC5D3346E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783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AC0706-7DC3-7945-913C-0FBB9CE19B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CA2CF8-BF76-3F41-8E7B-D9E224821A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77A7C0-E5BA-6148-A4C1-E17546AF0F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2B6DB0-57B1-AC41-958D-727EBC5D0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25165F-CD83-3840-947F-DF7517D036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A33B7B-DFAB-B64E-AD06-C2B130534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738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A23F27-D72E-4241-9A27-D9267ECA46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BE22E0-94F5-EA41-904E-606571FFE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135EB4-C642-EE4F-BB69-4982DEB11E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B5929C3-7251-5749-9C82-96C2DE51AD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430F3C9-6507-C04D-A4E2-424E0267F0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F7E58A-527B-164B-AA16-3F3203E37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D3DA907-63C8-8041-9F1D-9EBE0EC45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6E368C9-A1F9-7944-ACAE-EF3D205C1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014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74108E-7021-1645-8004-05C657F799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E84D2A-A2CB-1742-85BB-671DDE4DA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FFBD1EB-A30B-8949-B554-971927E22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D6BFD0D-EDAB-D247-879D-8682C5DF2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836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D0A313-FD7B-744F-9318-A559701D9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B35332A-A16C-614D-A88C-A3D7A38F86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443D01-4E2E-DE4D-A9CD-699AA138C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451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698F54-3EFC-3C4B-95C1-4343E81728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95ADF4-6426-1943-B6D8-F7138267E3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AFDA91-534B-104D-BE47-B99713EB77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91BB55-38AA-E442-92C8-EFA2B3585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3B929E-B1C5-6742-93F1-ABAD1DC57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4DB9A1-CF7A-BA4D-A939-97CC8D283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848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F012EA-097D-6443-A5CC-3050B2D3B8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A1D5939-63CE-204C-B47B-9BBB9C5D53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AF82CB-B532-894B-95B8-EA7429E4FF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FCBB37-E2EB-C546-A5F6-1CAF3DA6D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B84A8F-0CD3-CC47-A5D5-803BB5644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D571FF-48DD-0040-909F-28E761F1BC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470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9B94D0-8772-C749-93D3-5BFF53AB79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536E27-04A7-794A-BA55-D9A8A88968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3130B-29C2-1F40-8639-B908691E41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F33E2A-BEFE-264B-AF44-1A4BE38A7B12}" type="datetimeFigureOut">
              <a:rPr lang="en-US" smtClean="0"/>
              <a:t>5/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7A34DF-711D-A44D-AAEE-E3BB457D24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6DAB4F-CB76-4B47-A5CE-89FDB5BD4C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CDC20-A1DC-5A4B-BA3C-ABFF2F378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569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aolins@une.edu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1F3E44-79FC-1341-BC5A-C51DC59BB5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4"/>
            <a:ext cx="10515600" cy="5746918"/>
          </a:xfrm>
          <a:ln w="38100">
            <a:solidFill>
              <a:schemeClr val="accent5">
                <a:lumMod val="75000"/>
              </a:schemeClr>
            </a:solidFill>
          </a:ln>
        </p:spPr>
        <p:txBody>
          <a:bodyPr>
            <a:noAutofit/>
          </a:bodyPr>
          <a:lstStyle/>
          <a:p>
            <a:r>
              <a:rPr lang="en-US" sz="2000" b="1" u="sng" dirty="0"/>
              <a:t>Title:  </a:t>
            </a:r>
            <a:r>
              <a:rPr lang="en-US" sz="2000" b="1" dirty="0"/>
              <a:t>Epichromatin and Chromomeres: A “Fuzzy” Perspective</a:t>
            </a:r>
            <a:br>
              <a:rPr lang="en-US" sz="2000" dirty="0"/>
            </a:br>
            <a:r>
              <a:rPr lang="en-US" sz="2000" dirty="0"/>
              <a:t>Royal Society Open Biology</a:t>
            </a:r>
            <a:br>
              <a:rPr lang="en-US" sz="2000" dirty="0"/>
            </a:br>
            <a:r>
              <a:rPr lang="en-US" sz="2000" dirty="0"/>
              <a:t>DOI:  10.1098/rsob.18-0058</a:t>
            </a:r>
            <a:r>
              <a:rPr lang="en-US" sz="2000" dirty="0">
                <a:effectLst/>
              </a:rPr>
              <a:t> </a:t>
            </a:r>
            <a:br>
              <a:rPr lang="en-US" sz="2000" dirty="0">
                <a:effectLst/>
              </a:rPr>
            </a:br>
            <a:br>
              <a:rPr lang="en-US" sz="2000" dirty="0">
                <a:effectLst/>
              </a:rPr>
            </a:br>
            <a:r>
              <a:rPr lang="en-US" sz="2000" b="1" u="sng" dirty="0"/>
              <a:t>Supplementary Movie.  </a:t>
            </a:r>
            <a:r>
              <a:rPr lang="en-US" sz="2000" dirty="0"/>
              <a:t>A depiction of a possible molecular complex between bivalent PL2-6 and a dinucleosome, with the antibody binding sites abutting the nucleosome acidic patches (red spots on the nucleosome).  The bivalent antibody exhibits bilateral symmetry, displaying two L chains (red) and two H chains (brown and tan).  The antibody arms (Fab regions) were manipulated to bring them closer to the nucleosome acid patches. The dinucleosome is based on PDB 5OXV; the bivalent IgG molecule, on PDB 1iGT.  This movie was prepared by Gunnar Knobloch, Postdoctoral Fellow, LMU, Martinsried. </a:t>
            </a:r>
            <a:br>
              <a:rPr lang="en-US" sz="2000" dirty="0"/>
            </a:br>
            <a:br>
              <a:rPr lang="en-US" sz="2000" dirty="0"/>
            </a:br>
            <a:r>
              <a:rPr lang="en-US" sz="2000" dirty="0"/>
              <a:t>Authors:  Donald E. Olins and Ada L. Olins</a:t>
            </a:r>
            <a:br>
              <a:rPr lang="en-US" sz="2000" dirty="0"/>
            </a:br>
            <a:r>
              <a:rPr lang="en-US" sz="2000" dirty="0"/>
              <a:t>University of New England, College of Pharmacy</a:t>
            </a:r>
            <a:br>
              <a:rPr lang="en-US" sz="2000" dirty="0"/>
            </a:br>
            <a:r>
              <a:rPr lang="en-US" sz="2000" dirty="0"/>
              <a:t>Department of Pharmaceutical Sciences</a:t>
            </a:r>
            <a:br>
              <a:rPr lang="en-US" sz="2000" dirty="0"/>
            </a:br>
            <a:r>
              <a:rPr lang="en-US" sz="2000" dirty="0"/>
              <a:t>716 Stevens Avenue</a:t>
            </a:r>
            <a:br>
              <a:rPr lang="en-US" sz="2000" dirty="0"/>
            </a:br>
            <a:r>
              <a:rPr lang="en-US" sz="2000" dirty="0"/>
              <a:t>Portland, ME 04103</a:t>
            </a:r>
            <a:br>
              <a:rPr lang="en-US" sz="2000" dirty="0"/>
            </a:br>
            <a:r>
              <a:rPr lang="en-US" sz="2000" dirty="0" err="1"/>
              <a:t>d</a:t>
            </a:r>
            <a:r>
              <a:rPr lang="en-US" sz="2000" u="sng" dirty="0" err="1">
                <a:hlinkClick r:id="rId2"/>
              </a:rPr>
              <a:t>olins@une.edu</a:t>
            </a:r>
            <a:r>
              <a:rPr lang="en-US" sz="2000" dirty="0">
                <a:effectLst/>
              </a:rPr>
              <a:t> 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116295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Movie S1_1080.mov">
            <a:hlinkClick r:id="" action="ppaction://media"/>
            <a:extLst>
              <a:ext uri="{FF2B5EF4-FFF2-40B4-BE49-F238E27FC236}">
                <a16:creationId xmlns:a16="http://schemas.microsoft.com/office/drawing/2014/main" id="{25BB5F34-D98A-D342-8725-A8B54636F68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90798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60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3</TotalTime>
  <Words>16</Words>
  <Application>Microsoft Macintosh PowerPoint</Application>
  <PresentationFormat>Widescreen</PresentationFormat>
  <Paragraphs>3</Paragraphs>
  <Slides>2</Slides>
  <Notes>1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Title:  Epichromatin and Chromomeres: A “Fuzzy” Perspective Royal Society Open Biology DOI:  10.1098/rsob.18-0058   Supplementary Movie.  A depiction of a possible molecular complex between bivalent PL2-6 and a dinucleosome, with the antibody binding sites abutting the nucleosome acidic patches (red spots on the nucleosome).  The bivalent antibody exhibits bilateral symmetry, displaying two L chains (red) and two H chains (brown and tan).  The antibody arms (Fab regions) were manipulated to bring them closer to the nucleosome acid patches. The dinucleosome is based on PDB 5OXV; the bivalent IgG molecule, on PDB 1iGT.  This movie was prepared by Gunnar Knobloch, Postdoctoral Fellow, LMU, Martinsried.   Authors:  Donald E. Olins and Ada L. Olins University of New England, College of Pharmacy Department of Pharmaceutical Sciences 716 Stevens Avenue Portland, ME 04103 dolins@une.edu </vt:lpstr>
      <vt:lpstr>PowerPoint Presentation</vt:lpstr>
    </vt:vector>
  </TitlesOfParts>
  <Company/>
  <LinksUpToDate>false</LinksUpToDate>
  <SharedDoc>false</SharedDoc>
  <HyperlinksChanged>false</HyperlinksChanged>
  <AppVersion>16.001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a Olins</dc:creator>
  <cp:lastModifiedBy>Ada Olins</cp:lastModifiedBy>
  <cp:revision>6</cp:revision>
  <dcterms:created xsi:type="dcterms:W3CDTF">2018-05-08T12:58:53Z</dcterms:created>
  <dcterms:modified xsi:type="dcterms:W3CDTF">2018-05-08T20:42:19Z</dcterms:modified>
</cp:coreProperties>
</file>